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2" r:id="rId2"/>
  </p:sldIdLst>
  <p:sldSz cx="6858000" cy="9906000" type="A4"/>
  <p:notesSz cx="6858000" cy="9144000"/>
  <p:defaultTextStyle>
    <a:defPPr>
      <a:defRPr lang="en-US"/>
    </a:defPPr>
    <a:lvl1pPr marL="0" algn="l" defTabSz="804657" rtl="0" eaLnBrk="1" latinLnBrk="0" hangingPunct="1">
      <a:defRPr sz="1584" kern="1200">
        <a:solidFill>
          <a:schemeClr val="tx1"/>
        </a:solidFill>
        <a:latin typeface="+mn-lt"/>
        <a:ea typeface="+mn-ea"/>
        <a:cs typeface="+mn-cs"/>
      </a:defRPr>
    </a:lvl1pPr>
    <a:lvl2pPr marL="402329" algn="l" defTabSz="804657" rtl="0" eaLnBrk="1" latinLnBrk="0" hangingPunct="1">
      <a:defRPr sz="1584" kern="1200">
        <a:solidFill>
          <a:schemeClr val="tx1"/>
        </a:solidFill>
        <a:latin typeface="+mn-lt"/>
        <a:ea typeface="+mn-ea"/>
        <a:cs typeface="+mn-cs"/>
      </a:defRPr>
    </a:lvl2pPr>
    <a:lvl3pPr marL="804657" algn="l" defTabSz="804657" rtl="0" eaLnBrk="1" latinLnBrk="0" hangingPunct="1">
      <a:defRPr sz="1584" kern="1200">
        <a:solidFill>
          <a:schemeClr val="tx1"/>
        </a:solidFill>
        <a:latin typeface="+mn-lt"/>
        <a:ea typeface="+mn-ea"/>
        <a:cs typeface="+mn-cs"/>
      </a:defRPr>
    </a:lvl3pPr>
    <a:lvl4pPr marL="1206986" algn="l" defTabSz="804657" rtl="0" eaLnBrk="1" latinLnBrk="0" hangingPunct="1">
      <a:defRPr sz="1584" kern="1200">
        <a:solidFill>
          <a:schemeClr val="tx1"/>
        </a:solidFill>
        <a:latin typeface="+mn-lt"/>
        <a:ea typeface="+mn-ea"/>
        <a:cs typeface="+mn-cs"/>
      </a:defRPr>
    </a:lvl4pPr>
    <a:lvl5pPr marL="1609315" algn="l" defTabSz="804657" rtl="0" eaLnBrk="1" latinLnBrk="0" hangingPunct="1">
      <a:defRPr sz="1584" kern="1200">
        <a:solidFill>
          <a:schemeClr val="tx1"/>
        </a:solidFill>
        <a:latin typeface="+mn-lt"/>
        <a:ea typeface="+mn-ea"/>
        <a:cs typeface="+mn-cs"/>
      </a:defRPr>
    </a:lvl5pPr>
    <a:lvl6pPr marL="2011643" algn="l" defTabSz="804657" rtl="0" eaLnBrk="1" latinLnBrk="0" hangingPunct="1">
      <a:defRPr sz="1584" kern="1200">
        <a:solidFill>
          <a:schemeClr val="tx1"/>
        </a:solidFill>
        <a:latin typeface="+mn-lt"/>
        <a:ea typeface="+mn-ea"/>
        <a:cs typeface="+mn-cs"/>
      </a:defRPr>
    </a:lvl6pPr>
    <a:lvl7pPr marL="2413972" algn="l" defTabSz="804657" rtl="0" eaLnBrk="1" latinLnBrk="0" hangingPunct="1">
      <a:defRPr sz="1584" kern="1200">
        <a:solidFill>
          <a:schemeClr val="tx1"/>
        </a:solidFill>
        <a:latin typeface="+mn-lt"/>
        <a:ea typeface="+mn-ea"/>
        <a:cs typeface="+mn-cs"/>
      </a:defRPr>
    </a:lvl7pPr>
    <a:lvl8pPr marL="2816301" algn="l" defTabSz="804657" rtl="0" eaLnBrk="1" latinLnBrk="0" hangingPunct="1">
      <a:defRPr sz="1584" kern="1200">
        <a:solidFill>
          <a:schemeClr val="tx1"/>
        </a:solidFill>
        <a:latin typeface="+mn-lt"/>
        <a:ea typeface="+mn-ea"/>
        <a:cs typeface="+mn-cs"/>
      </a:defRPr>
    </a:lvl8pPr>
    <a:lvl9pPr marL="3218629" algn="l" defTabSz="804657" rtl="0" eaLnBrk="1" latinLnBrk="0" hangingPunct="1">
      <a:defRPr sz="158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FCDC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7" d="100"/>
          <a:sy n="57" d="100"/>
        </p:scale>
        <p:origin x="2630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D2070-7C86-487F-83FE-28AA24CF64CE}" type="datetimeFigureOut">
              <a:rPr lang="en-US" smtClean="0"/>
              <a:t>11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B91AC-6994-4CFE-9E6C-00C64355A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6405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D2070-7C86-487F-83FE-28AA24CF64CE}" type="datetimeFigureOut">
              <a:rPr lang="en-US" smtClean="0"/>
              <a:t>11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B91AC-6994-4CFE-9E6C-00C64355A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7286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D2070-7C86-487F-83FE-28AA24CF64CE}" type="datetimeFigureOut">
              <a:rPr lang="en-US" smtClean="0"/>
              <a:t>11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B91AC-6994-4CFE-9E6C-00C64355A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27895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D2070-7C86-487F-83FE-28AA24CF64CE}" type="datetimeFigureOut">
              <a:rPr lang="en-US" smtClean="0"/>
              <a:t>11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B91AC-6994-4CFE-9E6C-00C64355A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16229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D2070-7C86-487F-83FE-28AA24CF64CE}" type="datetimeFigureOut">
              <a:rPr lang="en-US" smtClean="0"/>
              <a:t>11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B91AC-6994-4CFE-9E6C-00C64355A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7970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D2070-7C86-487F-83FE-28AA24CF64CE}" type="datetimeFigureOut">
              <a:rPr lang="en-US" smtClean="0"/>
              <a:t>11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B91AC-6994-4CFE-9E6C-00C64355A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0055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D2070-7C86-487F-83FE-28AA24CF64CE}" type="datetimeFigureOut">
              <a:rPr lang="en-US" smtClean="0"/>
              <a:t>11/1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B91AC-6994-4CFE-9E6C-00C64355A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19238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D2070-7C86-487F-83FE-28AA24CF64CE}" type="datetimeFigureOut">
              <a:rPr lang="en-US" smtClean="0"/>
              <a:t>11/1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B91AC-6994-4CFE-9E6C-00C64355A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6062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D2070-7C86-487F-83FE-28AA24CF64CE}" type="datetimeFigureOut">
              <a:rPr lang="en-US" smtClean="0"/>
              <a:t>11/1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B91AC-6994-4CFE-9E6C-00C64355A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4359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D2070-7C86-487F-83FE-28AA24CF64CE}" type="datetimeFigureOut">
              <a:rPr lang="en-US" smtClean="0"/>
              <a:t>11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B91AC-6994-4CFE-9E6C-00C64355A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4361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D2070-7C86-487F-83FE-28AA24CF64CE}" type="datetimeFigureOut">
              <a:rPr lang="en-US" smtClean="0"/>
              <a:t>11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B91AC-6994-4CFE-9E6C-00C64355A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92177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7D2070-7C86-487F-83FE-28AA24CF64CE}" type="datetimeFigureOut">
              <a:rPr lang="en-US" smtClean="0"/>
              <a:t>11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DB91AC-6994-4CFE-9E6C-00C64355A9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21709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603" y="5508469"/>
            <a:ext cx="6190105" cy="34909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31" t="35391" r="688" b="21782"/>
          <a:stretch/>
        </p:blipFill>
        <p:spPr>
          <a:xfrm>
            <a:off x="340603" y="287168"/>
            <a:ext cx="3039946" cy="73152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603" y="1177893"/>
            <a:ext cx="6176793" cy="410654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39" t="35391" r="925" b="21782"/>
          <a:stretch/>
        </p:blipFill>
        <p:spPr>
          <a:xfrm>
            <a:off x="3429000" y="285015"/>
            <a:ext cx="3088396" cy="73875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2" name="TextBox 1"/>
          <p:cNvSpPr txBox="1"/>
          <p:nvPr/>
        </p:nvSpPr>
        <p:spPr>
          <a:xfrm>
            <a:off x="3380549" y="-12689"/>
            <a:ext cx="1793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verse primer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61429" y="-3834"/>
            <a:ext cx="1793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ward primer 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081174" y="7846209"/>
            <a:ext cx="62134" cy="56896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3480974" y="2662207"/>
            <a:ext cx="62134" cy="56896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0D67F5D-15A9-0624-F903-19EAE245025C}"/>
              </a:ext>
            </a:extLst>
          </p:cNvPr>
          <p:cNvSpPr txBox="1"/>
          <p:nvPr/>
        </p:nvSpPr>
        <p:spPr>
          <a:xfrm>
            <a:off x="228600" y="9011441"/>
            <a:ext cx="6456536" cy="9247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15000"/>
              </a:lnSpc>
              <a:buNone/>
            </a:pPr>
            <a:r>
              <a: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: Sanger sequencing following site-directed mutagenesis to confirm the p.(P565Q) VLDLR variant was successfully created.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lustal</a:t>
            </a:r>
            <a:r>
              <a: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mega alignment with the wild-type VLDLR transcript (NM_003383.5) was used to validate the successful introduction of the amino acid substitution.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16549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06</TotalTime>
  <Words>52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eel Jawabri</dc:creator>
  <cp:lastModifiedBy>Tariq Jawabri</cp:lastModifiedBy>
  <cp:revision>31</cp:revision>
  <dcterms:created xsi:type="dcterms:W3CDTF">2024-03-22T07:32:16Z</dcterms:created>
  <dcterms:modified xsi:type="dcterms:W3CDTF">2025-11-13T07:25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3d7eded-5fbb-4e74-baac-4decc5b8fd35_Enabled">
    <vt:lpwstr>true</vt:lpwstr>
  </property>
  <property fmtid="{D5CDD505-2E9C-101B-9397-08002B2CF9AE}" pid="3" name="MSIP_Label_d3d7eded-5fbb-4e74-baac-4decc5b8fd35_SetDate">
    <vt:lpwstr>2025-11-13T07:25:17Z</vt:lpwstr>
  </property>
  <property fmtid="{D5CDD505-2E9C-101B-9397-08002B2CF9AE}" pid="4" name="MSIP_Label_d3d7eded-5fbb-4e74-baac-4decc5b8fd35_Method">
    <vt:lpwstr>Standard</vt:lpwstr>
  </property>
  <property fmtid="{D5CDD505-2E9C-101B-9397-08002B2CF9AE}" pid="5" name="MSIP_Label_d3d7eded-5fbb-4e74-baac-4decc5b8fd35_Name">
    <vt:lpwstr>Liwa Label</vt:lpwstr>
  </property>
  <property fmtid="{D5CDD505-2E9C-101B-9397-08002B2CF9AE}" pid="6" name="MSIP_Label_d3d7eded-5fbb-4e74-baac-4decc5b8fd35_SiteId">
    <vt:lpwstr>83c04ed0-6d35-44e6-84ff-3ee7129a9c48</vt:lpwstr>
  </property>
  <property fmtid="{D5CDD505-2E9C-101B-9397-08002B2CF9AE}" pid="7" name="MSIP_Label_d3d7eded-5fbb-4e74-baac-4decc5b8fd35_ActionId">
    <vt:lpwstr>31baeb98-ccd6-4727-bab1-2c351c914e4b</vt:lpwstr>
  </property>
  <property fmtid="{D5CDD505-2E9C-101B-9397-08002B2CF9AE}" pid="8" name="MSIP_Label_d3d7eded-5fbb-4e74-baac-4decc5b8fd35_ContentBits">
    <vt:lpwstr>0</vt:lpwstr>
  </property>
  <property fmtid="{D5CDD505-2E9C-101B-9397-08002B2CF9AE}" pid="9" name="MSIP_Label_d3d7eded-5fbb-4e74-baac-4decc5b8fd35_Tag">
    <vt:lpwstr>10, 3, 0, 1</vt:lpwstr>
  </property>
</Properties>
</file>